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008062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58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692" y="108"/>
      </p:cViewPr>
      <p:guideLst>
        <p:guide orient="horz" pos="2160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122363"/>
            <a:ext cx="856853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3602038"/>
            <a:ext cx="7560469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2903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30112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365125"/>
            <a:ext cx="217363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365125"/>
            <a:ext cx="6394896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5356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7106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1709740"/>
            <a:ext cx="8694539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4589465"/>
            <a:ext cx="8694539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3715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1825625"/>
            <a:ext cx="4284266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1825625"/>
            <a:ext cx="4284266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0433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365127"/>
            <a:ext cx="8694539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1681163"/>
            <a:ext cx="426457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2505075"/>
            <a:ext cx="4264576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1681163"/>
            <a:ext cx="4285579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2505075"/>
            <a:ext cx="4285579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57539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98266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90652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57200"/>
            <a:ext cx="325126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987427"/>
            <a:ext cx="510331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057400"/>
            <a:ext cx="325126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4809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57200"/>
            <a:ext cx="325126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987427"/>
            <a:ext cx="510331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057400"/>
            <a:ext cx="325126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2486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365127"/>
            <a:ext cx="8694539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1825625"/>
            <a:ext cx="8694539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6356352"/>
            <a:ext cx="226814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0FD93-5DEE-44AE-A33B-E155559E4832}" type="datetimeFigureOut">
              <a:rPr lang="zh-TW" altLang="en-US" smtClean="0"/>
              <a:t>2025/12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6356352"/>
            <a:ext cx="340221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6356352"/>
            <a:ext cx="226814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DCF7F-F45E-4A0B-9E3E-74F79ECF646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87559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52F1D7B3-95EF-462F-9AFB-CCEFDCED88B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48" t="2591" b="18579"/>
          <a:stretch/>
        </p:blipFill>
        <p:spPr>
          <a:xfrm>
            <a:off x="2036825" y="47106"/>
            <a:ext cx="7725241" cy="5185135"/>
          </a:xfrm>
          <a:prstGeom prst="rect">
            <a:avLst/>
          </a:prstGeom>
        </p:spPr>
      </p:pic>
      <p:grpSp>
        <p:nvGrpSpPr>
          <p:cNvPr id="33" name="群組 32">
            <a:extLst>
              <a:ext uri="{FF2B5EF4-FFF2-40B4-BE49-F238E27FC236}">
                <a16:creationId xmlns:a16="http://schemas.microsoft.com/office/drawing/2014/main" id="{E05892C4-0D1C-4A50-BDBD-CF2C7BD14095}"/>
              </a:ext>
            </a:extLst>
          </p:cNvPr>
          <p:cNvGrpSpPr/>
          <p:nvPr/>
        </p:nvGrpSpPr>
        <p:grpSpPr>
          <a:xfrm>
            <a:off x="1632140" y="47106"/>
            <a:ext cx="588624" cy="4964597"/>
            <a:chOff x="1592357" y="86610"/>
            <a:chExt cx="588624" cy="4964597"/>
          </a:xfrm>
        </p:grpSpPr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5F6BBCAF-6B0F-4928-B3D5-1D1DF2EF498F}"/>
                </a:ext>
              </a:extLst>
            </p:cNvPr>
            <p:cNvSpPr txBox="1"/>
            <p:nvPr/>
          </p:nvSpPr>
          <p:spPr>
            <a:xfrm>
              <a:off x="1592357" y="86610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035F5326-FDB4-4246-93AB-AE831C278E1C}"/>
                </a:ext>
              </a:extLst>
            </p:cNvPr>
            <p:cNvSpPr txBox="1"/>
            <p:nvPr/>
          </p:nvSpPr>
          <p:spPr>
            <a:xfrm>
              <a:off x="1592358" y="995132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2C1394CD-6958-4774-86BB-B47F83F32BE6}"/>
                </a:ext>
              </a:extLst>
            </p:cNvPr>
            <p:cNvSpPr txBox="1"/>
            <p:nvPr/>
          </p:nvSpPr>
          <p:spPr>
            <a:xfrm>
              <a:off x="1592357" y="1913589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E867DDEF-F357-4A30-BEC5-7AED2C160640}"/>
                </a:ext>
              </a:extLst>
            </p:cNvPr>
            <p:cNvSpPr txBox="1"/>
            <p:nvPr/>
          </p:nvSpPr>
          <p:spPr>
            <a:xfrm>
              <a:off x="1592358" y="2835666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字方塊 9">
              <a:extLst>
                <a:ext uri="{FF2B5EF4-FFF2-40B4-BE49-F238E27FC236}">
                  <a16:creationId xmlns:a16="http://schemas.microsoft.com/office/drawing/2014/main" id="{E74ACBCB-65B7-402D-99DE-6A09123873BA}"/>
                </a:ext>
              </a:extLst>
            </p:cNvPr>
            <p:cNvSpPr txBox="1"/>
            <p:nvPr/>
          </p:nvSpPr>
          <p:spPr>
            <a:xfrm>
              <a:off x="1592358" y="3740569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FE758822-ABC2-4044-A9B4-7D028D8E5381}"/>
                </a:ext>
              </a:extLst>
            </p:cNvPr>
            <p:cNvSpPr txBox="1"/>
            <p:nvPr/>
          </p:nvSpPr>
          <p:spPr>
            <a:xfrm>
              <a:off x="1592357" y="4681875"/>
              <a:ext cx="588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zh-TW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77F2D694-2B0F-41D5-B490-72256ECF7768}"/>
              </a:ext>
            </a:extLst>
          </p:cNvPr>
          <p:cNvSpPr txBox="1"/>
          <p:nvPr/>
        </p:nvSpPr>
        <p:spPr>
          <a:xfrm>
            <a:off x="2296915" y="501507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B1290E1E-4D23-4FC4-8331-A46A0B9E79EC}"/>
              </a:ext>
            </a:extLst>
          </p:cNvPr>
          <p:cNvSpPr txBox="1"/>
          <p:nvPr/>
        </p:nvSpPr>
        <p:spPr>
          <a:xfrm>
            <a:off x="3683126" y="50148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5B42CBFF-04B9-4C4B-8309-648A410A8AE0}"/>
              </a:ext>
            </a:extLst>
          </p:cNvPr>
          <p:cNvSpPr txBox="1"/>
          <p:nvPr/>
        </p:nvSpPr>
        <p:spPr>
          <a:xfrm>
            <a:off x="5069337" y="50148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FC4C8218-0919-45EC-AF36-D40E19F1E617}"/>
              </a:ext>
            </a:extLst>
          </p:cNvPr>
          <p:cNvSpPr txBox="1"/>
          <p:nvPr/>
        </p:nvSpPr>
        <p:spPr>
          <a:xfrm>
            <a:off x="6455548" y="50148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89C38D31-119B-470A-957C-A5B81F087355}"/>
              </a:ext>
            </a:extLst>
          </p:cNvPr>
          <p:cNvSpPr txBox="1"/>
          <p:nvPr/>
        </p:nvSpPr>
        <p:spPr>
          <a:xfrm>
            <a:off x="7841759" y="50148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7D5DE732-1C98-4E80-AC7B-5EA732A73944}"/>
              </a:ext>
            </a:extLst>
          </p:cNvPr>
          <p:cNvSpPr txBox="1"/>
          <p:nvPr/>
        </p:nvSpPr>
        <p:spPr>
          <a:xfrm>
            <a:off x="9227968" y="50110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79CB7376-E9F3-40E5-BC08-4E8560A30CD6}"/>
              </a:ext>
            </a:extLst>
          </p:cNvPr>
          <p:cNvSpPr txBox="1"/>
          <p:nvPr/>
        </p:nvSpPr>
        <p:spPr>
          <a:xfrm rot="16200000">
            <a:off x="-827065" y="2478211"/>
            <a:ext cx="4229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umulative incidence rate of sepsis</a:t>
            </a:r>
            <a:endParaRPr lang="zh-TW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DB5D273D-93D8-4FE4-99E1-37CE44C33D06}"/>
              </a:ext>
            </a:extLst>
          </p:cNvPr>
          <p:cNvSpPr txBox="1"/>
          <p:nvPr/>
        </p:nvSpPr>
        <p:spPr>
          <a:xfrm>
            <a:off x="5083358" y="5384135"/>
            <a:ext cx="15221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Years)</a:t>
            </a:r>
            <a:endParaRPr lang="zh-TW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9077FDB9-68CE-44D3-ADD1-1FDE1D46D8B1}"/>
              </a:ext>
            </a:extLst>
          </p:cNvPr>
          <p:cNvSpPr txBox="1"/>
          <p:nvPr/>
        </p:nvSpPr>
        <p:spPr>
          <a:xfrm>
            <a:off x="356792" y="5798540"/>
            <a:ext cx="156966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P-4i users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LT2i users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F6487F7A-9F6F-42F8-A372-134E57D21990}"/>
              </a:ext>
            </a:extLst>
          </p:cNvPr>
          <p:cNvSpPr txBox="1"/>
          <p:nvPr/>
        </p:nvSpPr>
        <p:spPr>
          <a:xfrm>
            <a:off x="2045253" y="5798540"/>
            <a:ext cx="7618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344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672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0B52650A-D24F-47DC-8AAA-A7D543355CE6}"/>
              </a:ext>
            </a:extLst>
          </p:cNvPr>
          <p:cNvSpPr txBox="1"/>
          <p:nvPr/>
        </p:nvSpPr>
        <p:spPr>
          <a:xfrm>
            <a:off x="3452600" y="5798540"/>
            <a:ext cx="7618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605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571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863B9ED8-1D16-4788-A4CD-970E826A7484}"/>
              </a:ext>
            </a:extLst>
          </p:cNvPr>
          <p:cNvSpPr txBox="1"/>
          <p:nvPr/>
        </p:nvSpPr>
        <p:spPr>
          <a:xfrm>
            <a:off x="4859947" y="5798540"/>
            <a:ext cx="7618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912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259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C73D45B4-CCCE-4F5B-B375-F48BAD86C16A}"/>
              </a:ext>
            </a:extLst>
          </p:cNvPr>
          <p:cNvSpPr txBox="1"/>
          <p:nvPr/>
        </p:nvSpPr>
        <p:spPr>
          <a:xfrm>
            <a:off x="6241893" y="5798540"/>
            <a:ext cx="7618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921</a:t>
            </a:r>
          </a:p>
          <a:p>
            <a:pPr algn="ct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90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5889BF95-E154-4CEC-B417-6EC56CE09D92}"/>
              </a:ext>
            </a:extLst>
          </p:cNvPr>
          <p:cNvSpPr txBox="1"/>
          <p:nvPr/>
        </p:nvSpPr>
        <p:spPr>
          <a:xfrm>
            <a:off x="7688454" y="5798540"/>
            <a:ext cx="64639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89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08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770E6550-A316-4F16-BCB8-B551937E5E04}"/>
              </a:ext>
            </a:extLst>
          </p:cNvPr>
          <p:cNvSpPr txBox="1"/>
          <p:nvPr/>
        </p:nvSpPr>
        <p:spPr>
          <a:xfrm>
            <a:off x="9211002" y="5798540"/>
            <a:ext cx="30014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en-US" altLang="zh-TW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  <a:p>
            <a:pPr algn="r"/>
            <a:r>
              <a:rPr lang="en-US" altLang="zh-TW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1D80D572-8042-42CA-8F01-282365DFA3D3}"/>
              </a:ext>
            </a:extLst>
          </p:cNvPr>
          <p:cNvSpPr txBox="1"/>
          <p:nvPr/>
        </p:nvSpPr>
        <p:spPr>
          <a:xfrm>
            <a:off x="3415677" y="223585"/>
            <a:ext cx="12634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P-4i users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D440F759-C182-486B-B929-98284CC8356C}"/>
              </a:ext>
            </a:extLst>
          </p:cNvPr>
          <p:cNvSpPr txBox="1"/>
          <p:nvPr/>
        </p:nvSpPr>
        <p:spPr>
          <a:xfrm>
            <a:off x="5803327" y="223585"/>
            <a:ext cx="13119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LT2i users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FCF78EA2-51D7-4EB2-AEE3-BB864C50FA13}"/>
              </a:ext>
            </a:extLst>
          </p:cNvPr>
          <p:cNvSpPr txBox="1"/>
          <p:nvPr/>
        </p:nvSpPr>
        <p:spPr>
          <a:xfrm>
            <a:off x="7976491" y="1625759"/>
            <a:ext cx="148470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p&lt;0.0001</a:t>
            </a:r>
            <a:endParaRPr lang="zh-TW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8764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49</Words>
  <Application>Microsoft Office PowerPoint</Application>
  <PresentationFormat>自訂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u YC</dc:creator>
  <cp:lastModifiedBy>Wu YC</cp:lastModifiedBy>
  <cp:revision>9</cp:revision>
  <dcterms:created xsi:type="dcterms:W3CDTF">2025-12-04T02:42:18Z</dcterms:created>
  <dcterms:modified xsi:type="dcterms:W3CDTF">2025-12-04T03:14:25Z</dcterms:modified>
</cp:coreProperties>
</file>